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118" y="21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819FF-474D-4B06-A680-7DC105412705}" type="datetimeFigureOut">
              <a:rPr lang="en-US" smtClean="0"/>
              <a:t>11/1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00947-7EBE-4DE8-804C-9E22BE907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15153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819FF-474D-4B06-A680-7DC105412705}" type="datetimeFigureOut">
              <a:rPr lang="en-US" smtClean="0"/>
              <a:t>11/1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00947-7EBE-4DE8-804C-9E22BE907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12951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819FF-474D-4B06-A680-7DC105412705}" type="datetimeFigureOut">
              <a:rPr lang="en-US" smtClean="0"/>
              <a:t>11/1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00947-7EBE-4DE8-804C-9E22BE907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58419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819FF-474D-4B06-A680-7DC105412705}" type="datetimeFigureOut">
              <a:rPr lang="en-US" smtClean="0"/>
              <a:t>11/1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00947-7EBE-4DE8-804C-9E22BE907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34132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819FF-474D-4B06-A680-7DC105412705}" type="datetimeFigureOut">
              <a:rPr lang="en-US" smtClean="0"/>
              <a:t>11/1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00947-7EBE-4DE8-804C-9E22BE907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49972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819FF-474D-4B06-A680-7DC105412705}" type="datetimeFigureOut">
              <a:rPr lang="en-US" smtClean="0"/>
              <a:t>11/13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00947-7EBE-4DE8-804C-9E22BE907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66236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819FF-474D-4B06-A680-7DC105412705}" type="datetimeFigureOut">
              <a:rPr lang="en-US" smtClean="0"/>
              <a:t>11/13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00947-7EBE-4DE8-804C-9E22BE907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25880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819FF-474D-4B06-A680-7DC105412705}" type="datetimeFigureOut">
              <a:rPr lang="en-US" smtClean="0"/>
              <a:t>11/13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00947-7EBE-4DE8-804C-9E22BE907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0621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819FF-474D-4B06-A680-7DC105412705}" type="datetimeFigureOut">
              <a:rPr lang="en-US" smtClean="0"/>
              <a:t>11/13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00947-7EBE-4DE8-804C-9E22BE907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73571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819FF-474D-4B06-A680-7DC105412705}" type="datetimeFigureOut">
              <a:rPr lang="en-US" smtClean="0"/>
              <a:t>11/13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00947-7EBE-4DE8-804C-9E22BE907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54566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819FF-474D-4B06-A680-7DC105412705}" type="datetimeFigureOut">
              <a:rPr lang="en-US" smtClean="0"/>
              <a:t>11/13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00947-7EBE-4DE8-804C-9E22BE907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36507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1819FF-474D-4B06-A680-7DC105412705}" type="datetimeFigureOut">
              <a:rPr lang="en-US" smtClean="0"/>
              <a:t>11/1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E00947-7EBE-4DE8-804C-9E22BE907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84258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206"/>
          <a:stretch/>
        </p:blipFill>
        <p:spPr bwMode="auto">
          <a:xfrm>
            <a:off x="1905000" y="1648326"/>
            <a:ext cx="2493963" cy="20648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797"/>
          <a:stretch/>
        </p:blipFill>
        <p:spPr bwMode="auto">
          <a:xfrm>
            <a:off x="762000" y="3986210"/>
            <a:ext cx="2438400" cy="20288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8054"/>
          <a:stretch/>
        </p:blipFill>
        <p:spPr bwMode="auto">
          <a:xfrm>
            <a:off x="3429000" y="3986210"/>
            <a:ext cx="2438400" cy="19981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627981" y="1162050"/>
            <a:ext cx="3048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tersection of </a:t>
            </a:r>
            <a:r>
              <a:rPr lang="en-US" sz="1400" b="1" dirty="0" smtClean="0">
                <a:solidFill>
                  <a:srgbClr val="7030A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urple</a:t>
            </a:r>
            <a:r>
              <a:rPr lang="en-US" sz="1400" dirty="0" smtClean="0">
                <a:solidFill>
                  <a:srgbClr val="7030A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s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42900" y="3678432"/>
            <a:ext cx="3276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tersection of </a:t>
            </a:r>
            <a:r>
              <a:rPr lang="en-US" sz="1400" b="1" dirty="0" smtClean="0">
                <a:solidFill>
                  <a:schemeClr val="accent5">
                    <a:lumMod val="60000"/>
                    <a:lumOff val="4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ght Blue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s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448050" y="3678433"/>
            <a:ext cx="3048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ersection of </a:t>
            </a:r>
            <a:r>
              <a:rPr lang="en-US" sz="1400" b="1" dirty="0" smtClean="0">
                <a:solidFill>
                  <a:schemeClr val="accent6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range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enes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885953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</TotalTime>
  <Words>19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deau, Jeff</dc:creator>
  <cp:lastModifiedBy>Nadeau, Jeff</cp:lastModifiedBy>
  <cp:revision>4</cp:revision>
  <dcterms:created xsi:type="dcterms:W3CDTF">2016-08-17T21:11:50Z</dcterms:created>
  <dcterms:modified xsi:type="dcterms:W3CDTF">2016-11-13T22:17:24Z</dcterms:modified>
</cp:coreProperties>
</file>